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919B96-85FC-4DA8-8681-90BEB86A579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ECDD36-D58B-40EE-A6D2-C3E92EFB9B9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34FC62-9B38-411E-B96B-AEEC3C5B367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9431C8-2F93-4BD2-9DCE-EB68E20AA61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2CCD45-2F2F-4981-888E-069610A8B50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F67D7C-7833-4A04-9857-F1D1EA63AC3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3B7A5C-7094-44DA-805B-ED4F838FAEA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587A09-80D3-49B6-9E5F-2D841FEBF62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023D95-6D75-4765-8568-0A9EB10977B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41C677-8FDF-4EA3-905A-F809EA6565C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FEAE0A-DD7D-42A8-AF53-5EA6A8CB6C3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EDD178-F34F-4762-8010-93772A71588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nl-NL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2F4F9D3-8872-4CBC-A3D6-6A6E2662FAEC}" type="slidenum">
              <a:rPr b="0" lang="nl-NL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4" descr="pdcd40-20x-pos control"/>
          <p:cNvPicPr/>
          <p:nvPr/>
        </p:nvPicPr>
        <p:blipFill>
          <a:blip r:embed="rId1"/>
          <a:stretch/>
        </p:blipFill>
        <p:spPr>
          <a:xfrm>
            <a:off x="260280" y="344520"/>
            <a:ext cx="2865600" cy="212724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5" descr="pdcd40-40x-pos control"/>
          <p:cNvPicPr/>
          <p:nvPr/>
        </p:nvPicPr>
        <p:blipFill>
          <a:blip r:embed="rId2"/>
          <a:stretch/>
        </p:blipFill>
        <p:spPr>
          <a:xfrm>
            <a:off x="3500280" y="344520"/>
            <a:ext cx="2865600" cy="212724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8" descr="pdcd40-20x-neg control"/>
          <p:cNvPicPr/>
          <p:nvPr/>
        </p:nvPicPr>
        <p:blipFill>
          <a:blip r:embed="rId3"/>
          <a:stretch/>
        </p:blipFill>
        <p:spPr>
          <a:xfrm>
            <a:off x="260280" y="2865600"/>
            <a:ext cx="2865600" cy="212724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9" descr="pdcd40-40x-neg control"/>
          <p:cNvPicPr/>
          <p:nvPr/>
        </p:nvPicPr>
        <p:blipFill>
          <a:blip r:embed="rId4"/>
          <a:stretch/>
        </p:blipFill>
        <p:spPr>
          <a:xfrm>
            <a:off x="3500280" y="2865600"/>
            <a:ext cx="2865600" cy="2127240"/>
          </a:xfrm>
          <a:prstGeom prst="rect">
            <a:avLst/>
          </a:prstGeom>
          <a:ln w="0">
            <a:noFill/>
          </a:ln>
        </p:spPr>
      </p:pic>
      <p:sp>
        <p:nvSpPr>
          <p:cNvPr id="45" name="Text Box 10"/>
          <p:cNvSpPr/>
          <p:nvPr/>
        </p:nvSpPr>
        <p:spPr>
          <a:xfrm>
            <a:off x="168120" y="5189400"/>
            <a:ext cx="650088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PDCD4 staining in normal colonic epithelium (positive control, A : 200x, B: 400x magnification) and in intestinal type colon carcinoma (negative control, C: 200x, D: 400x magnification). (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udduluru G, et al.,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Cancer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2007,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10: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1697-1707.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11"/>
          <p:cNvSpPr/>
          <p:nvPr/>
        </p:nvSpPr>
        <p:spPr>
          <a:xfrm>
            <a:off x="5877000" y="4521240"/>
            <a:ext cx="360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8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12"/>
          <p:cNvSpPr/>
          <p:nvPr/>
        </p:nvSpPr>
        <p:spPr>
          <a:xfrm>
            <a:off x="2708280" y="2073240"/>
            <a:ext cx="360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13"/>
          <p:cNvSpPr/>
          <p:nvPr/>
        </p:nvSpPr>
        <p:spPr>
          <a:xfrm>
            <a:off x="2637000" y="4521240"/>
            <a:ext cx="360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14"/>
          <p:cNvSpPr/>
          <p:nvPr/>
        </p:nvSpPr>
        <p:spPr>
          <a:xfrm>
            <a:off x="5877000" y="2073240"/>
            <a:ext cx="360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0" name="Group 17"/>
          <p:cNvGrpSpPr/>
          <p:nvPr/>
        </p:nvGrpSpPr>
        <p:grpSpPr>
          <a:xfrm>
            <a:off x="333360" y="6032520"/>
            <a:ext cx="6033960" cy="3549960"/>
            <a:chOff x="333360" y="6032520"/>
            <a:chExt cx="6033960" cy="3549960"/>
          </a:xfrm>
        </p:grpSpPr>
        <p:pic>
          <p:nvPicPr>
            <p:cNvPr id="51" name="Picture 18" descr="tpm1-20x-pos control colon"/>
            <p:cNvPicPr/>
            <p:nvPr/>
          </p:nvPicPr>
          <p:blipFill>
            <a:blip r:embed="rId5"/>
            <a:stretch/>
          </p:blipFill>
          <p:spPr>
            <a:xfrm>
              <a:off x="333360" y="6032520"/>
              <a:ext cx="2865240" cy="2127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2" name="Picture 19" descr="tpm1-40x-pos control colon"/>
            <p:cNvPicPr/>
            <p:nvPr/>
          </p:nvPicPr>
          <p:blipFill>
            <a:blip r:embed="rId6"/>
            <a:stretch/>
          </p:blipFill>
          <p:spPr>
            <a:xfrm>
              <a:off x="3502080" y="6032520"/>
              <a:ext cx="2865240" cy="2127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3" name="Text Box 20"/>
            <p:cNvSpPr/>
            <p:nvPr/>
          </p:nvSpPr>
          <p:spPr>
            <a:xfrm>
              <a:off x="406440" y="8480520"/>
              <a:ext cx="5832360" cy="110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nl-NL" sz="1200" spc="-1" strike="noStrike">
                  <a:solidFill>
                    <a:srgbClr val="000000"/>
                  </a:solidFill>
                  <a:latin typeface="Arial"/>
                </a:rPr>
                <a:t>Tropomyosin 1 staining in colon. Note specific staining of smooth muscle of the muscularis mucosae (*) and of the capillary wall (□), whereas the epithelium and lymphoid cells are negative (A:  200x, B: 400x magnification) (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Mirza ZK, et al., 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Inflamm Bowel Dis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 2006,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12: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 1036-1043).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Rectangle 21"/>
            <p:cNvSpPr/>
            <p:nvPr/>
          </p:nvSpPr>
          <p:spPr>
            <a:xfrm>
              <a:off x="2855880" y="7759800"/>
              <a:ext cx="333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nl-NL" sz="1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Rectangle 22"/>
            <p:cNvSpPr/>
            <p:nvPr/>
          </p:nvSpPr>
          <p:spPr>
            <a:xfrm>
              <a:off x="6024600" y="7759800"/>
              <a:ext cx="333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nl-NL" sz="1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 Box 23"/>
            <p:cNvSpPr/>
            <p:nvPr/>
          </p:nvSpPr>
          <p:spPr>
            <a:xfrm>
              <a:off x="1270080" y="7112160"/>
              <a:ext cx="64764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50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24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 Box 24"/>
            <p:cNvSpPr/>
            <p:nvPr/>
          </p:nvSpPr>
          <p:spPr>
            <a:xfrm>
              <a:off x="3933720" y="6392880"/>
              <a:ext cx="64764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50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nl-NL" sz="24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 Box 25"/>
            <p:cNvSpPr/>
            <p:nvPr/>
          </p:nvSpPr>
          <p:spPr>
            <a:xfrm>
              <a:off x="4871880" y="7327800"/>
              <a:ext cx="3193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nl-NL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□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 Box 26"/>
            <p:cNvSpPr/>
            <p:nvPr/>
          </p:nvSpPr>
          <p:spPr>
            <a:xfrm>
              <a:off x="2063520" y="7616880"/>
              <a:ext cx="3193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nl-NL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□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4-24T11:25:30Z</dcterms:created>
  <dc:creator>dr. J. Bart</dc:creator>
  <dc:description/>
  <dc:language>en-US</dc:language>
  <cp:lastModifiedBy>qil</cp:lastModifiedBy>
  <dcterms:modified xsi:type="dcterms:W3CDTF">2009-05-22T13:16:54Z</dcterms:modified>
  <cp:revision>7</cp:revision>
  <dc:subject/>
  <dc:title>Dia 1</dc:title>
</cp:coreProperties>
</file>